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77EA2E2-1137-4CD2-B726-4C35D0EB49F2}" v="1" dt="2024-10-10T06:50:55.69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A77EA2E2-1137-4CD2-B726-4C35D0EB49F2}"/>
    <pc:docChg chg="undo custSel addSld delSld modSld">
      <pc:chgData name="赤堀　ゆきこ" userId="bbfeda90-9ade-440e-995a-5a1e8cff3baf" providerId="ADAL" clId="{A77EA2E2-1137-4CD2-B726-4C35D0EB49F2}" dt="2024-10-10T07:15:19.137" v="18" actId="2711"/>
      <pc:docMkLst>
        <pc:docMk/>
      </pc:docMkLst>
      <pc:sldChg chg="modSp add mod">
        <pc:chgData name="赤堀　ゆきこ" userId="bbfeda90-9ade-440e-995a-5a1e8cff3baf" providerId="ADAL" clId="{A77EA2E2-1137-4CD2-B726-4C35D0EB49F2}" dt="2024-10-10T07:15:19.137" v="18" actId="2711"/>
        <pc:sldMkLst>
          <pc:docMk/>
          <pc:sldMk cId="13072062" sldId="263"/>
        </pc:sldMkLst>
        <pc:spChg chg="mod">
          <ac:chgData name="赤堀　ゆきこ" userId="bbfeda90-9ade-440e-995a-5a1e8cff3baf" providerId="ADAL" clId="{A77EA2E2-1137-4CD2-B726-4C35D0EB49F2}" dt="2024-10-10T07:08:45.653" v="2" actId="255"/>
          <ac:spMkLst>
            <pc:docMk/>
            <pc:sldMk cId="13072062" sldId="263"/>
            <ac:spMk id="5" creationId="{FFDD177D-54D0-4307-F71F-74D18DBADB39}"/>
          </ac:spMkLst>
        </pc:spChg>
        <pc:graphicFrameChg chg="mod modGraphic">
          <ac:chgData name="赤堀　ゆきこ" userId="bbfeda90-9ade-440e-995a-5a1e8cff3baf" providerId="ADAL" clId="{A77EA2E2-1137-4CD2-B726-4C35D0EB49F2}" dt="2024-10-10T07:15:19.137" v="18" actId="2711"/>
          <ac:graphicFrameMkLst>
            <pc:docMk/>
            <pc:sldMk cId="13072062" sldId="263"/>
            <ac:graphicFrameMk id="4" creationId="{3B79122C-7ECE-E3E2-635A-F5E93202F8FA}"/>
          </ac:graphicFrameMkLst>
        </pc:graphicFrameChg>
      </pc:sldChg>
      <pc:sldChg chg="del">
        <pc:chgData name="赤堀　ゆきこ" userId="bbfeda90-9ade-440e-995a-5a1e8cff3baf" providerId="ADAL" clId="{A77EA2E2-1137-4CD2-B726-4C35D0EB49F2}" dt="2024-10-10T06:50:57.259" v="1" actId="47"/>
        <pc:sldMkLst>
          <pc:docMk/>
          <pc:sldMk cId="1150512429" sldId="264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FDD177D-54D0-4307-F71F-74D18DBADB39}"/>
              </a:ext>
            </a:extLst>
          </p:cNvPr>
          <p:cNvSpPr txBox="1"/>
          <p:nvPr/>
        </p:nvSpPr>
        <p:spPr>
          <a:xfrm>
            <a:off x="813777" y="3248442"/>
            <a:ext cx="23102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2 Table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C value of serotypes 1 and 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5B5138-BB60-FC0E-EB17-9516FC4597EB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B79122C-7ECE-E3E2-635A-F5E93202F8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0196600"/>
              </p:ext>
            </p:extLst>
          </p:nvPr>
        </p:nvGraphicFramePr>
        <p:xfrm>
          <a:off x="100886" y="3866233"/>
          <a:ext cx="6656228" cy="13716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979714">
                  <a:extLst>
                    <a:ext uri="{9D8B030D-6E8A-4147-A177-3AD203B41FA5}">
                      <a16:colId xmlns:a16="http://schemas.microsoft.com/office/drawing/2014/main" val="1976928964"/>
                    </a:ext>
                  </a:extLst>
                </a:gridCol>
                <a:gridCol w="775960">
                  <a:extLst>
                    <a:ext uri="{9D8B030D-6E8A-4147-A177-3AD203B41FA5}">
                      <a16:colId xmlns:a16="http://schemas.microsoft.com/office/drawing/2014/main" val="21703623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3521675195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1925787993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3494011127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2132050033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499597001"/>
                    </a:ext>
                  </a:extLst>
                </a:gridCol>
                <a:gridCol w="816759">
                  <a:extLst>
                    <a:ext uri="{9D8B030D-6E8A-4147-A177-3AD203B41FA5}">
                      <a16:colId xmlns:a16="http://schemas.microsoft.com/office/drawing/2014/main" val="55625773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iotics</a:t>
                      </a:r>
                    </a:p>
                    <a:p>
                      <a:r>
                        <a:rPr kumimoji="1" lang="en-US" altLang="ja-JP" sz="1200" dirty="0"/>
                        <a:t>(</a:t>
                      </a:r>
                      <a:r>
                        <a:rPr lang="en-US" altLang="ja-JP" sz="1200" b="1" u="none" strike="noStrike" dirty="0">
                          <a:effectLst/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mL</a:t>
                      </a:r>
                      <a:r>
                        <a:rPr kumimoji="1" lang="en-US" altLang="ja-JP" sz="1200" dirty="0"/>
                        <a:t>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P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X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FX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5511762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 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 (</a:t>
                      </a:r>
                      <a:r>
                        <a:rPr lang="en-US" altLang="ja-JP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19795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 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 (</a:t>
                      </a:r>
                      <a:r>
                        <a:rPr lang="en-US" altLang="ja-JP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I</a:t>
                      </a:r>
                      <a:r>
                        <a:rPr lang="en-US" altLang="ja-JP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 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r>
                        <a:rPr lang="en-US" altLang="ja-JP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S)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334651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072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96</Words>
  <Application>Microsoft Office PowerPoint</Application>
  <PresentationFormat>A4 210 x 297 mm</PresentationFormat>
  <Paragraphs>3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赤堀　ゆきこ</cp:lastModifiedBy>
  <cp:revision>5</cp:revision>
  <dcterms:created xsi:type="dcterms:W3CDTF">2024-10-10T06:46:11Z</dcterms:created>
  <dcterms:modified xsi:type="dcterms:W3CDTF">2024-10-10T07:15:21Z</dcterms:modified>
</cp:coreProperties>
</file>